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774" y="-102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D3B2A-DE4C-4266-A8A1-7034EFE1AB97}" type="datetimeFigureOut">
              <a:rPr lang="de-DE" smtClean="0"/>
              <a:pPr/>
              <a:t>05.02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AEA02-ADED-4FB2-8B16-8AADE18D6EA8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205093" y="2876719"/>
            <a:ext cx="419742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S1. Evaluation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newl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esigne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‚</a:t>
            </a:r>
            <a:r>
              <a:rPr lang="de-DE" sz="1200" b="1" i="1" dirty="0" err="1" smtClean="0">
                <a:latin typeface="Arial" pitchFamily="34" charset="0"/>
                <a:cs typeface="Arial" pitchFamily="34" charset="0"/>
              </a:rPr>
              <a:t>Candidatu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iscichlamydi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almoni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‘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pecific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probe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Psc-523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using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lon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-FISH.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araformaldehyde-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ix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E. coli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JM109 (DE3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ntainin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in vivo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ranscrib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‘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Candidatus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iscichlamydia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almon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‘ 16S rRNA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hybridiz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 An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ligonucleotid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robe mix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argetin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ost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i="1" dirty="0" err="1">
                <a:latin typeface="Arial" pitchFamily="34" charset="0"/>
                <a:cs typeface="Arial" pitchFamily="34" charset="0"/>
              </a:rPr>
              <a:t>B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acteria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labell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luo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ee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‚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Candidatus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iscichlamydia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almon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‘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pecific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robe Psc-523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labell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in Cy3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was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us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 The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mbin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luorescenc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ignal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both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robe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ppear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yellow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emonstratin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at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robe Psc-523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uitabl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o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etect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‘</a:t>
            </a:r>
            <a:r>
              <a:rPr lang="de-DE" sz="1200" i="1" dirty="0" err="1">
                <a:latin typeface="Arial" pitchFamily="34" charset="0"/>
                <a:cs typeface="Arial" pitchFamily="34" charset="0"/>
              </a:rPr>
              <a:t>Candidatus</a:t>
            </a:r>
            <a:r>
              <a:rPr lang="de-DE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Piscichlamydia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almon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‘.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cal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bar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epresent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2 µm.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Gruppieren 6"/>
          <p:cNvGrpSpPr>
            <a:grpSpLocks noChangeAspect="1"/>
          </p:cNvGrpSpPr>
          <p:nvPr/>
        </p:nvGrpSpPr>
        <p:grpSpPr>
          <a:xfrm>
            <a:off x="898906" y="1412776"/>
            <a:ext cx="4092455" cy="3960440"/>
            <a:chOff x="1907704" y="1556792"/>
            <a:chExt cx="2232248" cy="2160240"/>
          </a:xfrm>
        </p:grpSpPr>
        <p:pic>
          <p:nvPicPr>
            <p:cNvPr id="8" name="Grafik 7" descr="35%Eubmix_Fluos,Psc-523_Cy3.tif"/>
            <p:cNvPicPr>
              <a:picLocks noChangeAspect="1"/>
            </p:cNvPicPr>
            <p:nvPr/>
          </p:nvPicPr>
          <p:blipFill>
            <a:blip r:embed="rId2" cstate="print"/>
            <a:srcRect l="20563" t="9347" r="21487" b="34572"/>
            <a:stretch>
              <a:fillRect/>
            </a:stretch>
          </p:blipFill>
          <p:spPr>
            <a:xfrm>
              <a:off x="1907704" y="1556792"/>
              <a:ext cx="2232248" cy="2160240"/>
            </a:xfrm>
            <a:prstGeom prst="rect">
              <a:avLst/>
            </a:prstGeom>
          </p:spPr>
        </p:pic>
        <p:cxnSp>
          <p:nvCxnSpPr>
            <p:cNvPr id="9" name="Gerade Verbindung 8"/>
            <p:cNvCxnSpPr/>
            <p:nvPr/>
          </p:nvCxnSpPr>
          <p:spPr>
            <a:xfrm>
              <a:off x="3854744" y="3614392"/>
              <a:ext cx="162000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Larissa-Design</vt:lpstr>
      <vt:lpstr>PowerPoint-presentasjon</vt:lpstr>
    </vt:vector>
  </TitlesOfParts>
  <Company>Universitaet Wi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toenshe8</dc:creator>
  <cp:lastModifiedBy>Colquhoun, Duncan</cp:lastModifiedBy>
  <cp:revision>73</cp:revision>
  <dcterms:created xsi:type="dcterms:W3CDTF">2011-04-13T12:19:10Z</dcterms:created>
  <dcterms:modified xsi:type="dcterms:W3CDTF">2012-02-05T08:58:41Z</dcterms:modified>
</cp:coreProperties>
</file>